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38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SDHA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2h88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2h88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00034" y="214291"/>
            <a:ext cx="3286148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32430" y="142853"/>
            <a:ext cx="3625850" cy="2786081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0034" y="3214686"/>
            <a:ext cx="3286148" cy="27146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143248"/>
            <a:ext cx="3643338" cy="2857521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82</cp:revision>
  <dcterms:created xsi:type="dcterms:W3CDTF">2018-05-10T07:33:24Z</dcterms:created>
  <dcterms:modified xsi:type="dcterms:W3CDTF">2018-05-29T07:43:30Z</dcterms:modified>
</cp:coreProperties>
</file>